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3250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46:$U$46</c:f>
                <c:numCache>
                  <c:formatCode>General</c:formatCode>
                  <c:ptCount val="8"/>
                  <c:pt idx="0">
                    <c:v>1.5233460901119433E-2</c:v>
                  </c:pt>
                  <c:pt idx="1">
                    <c:v>4.7344191994281068E-2</c:v>
                  </c:pt>
                  <c:pt idx="2">
                    <c:v>6.7905102591764022E-3</c:v>
                  </c:pt>
                  <c:pt idx="3">
                    <c:v>6.5366807530927214E-3</c:v>
                  </c:pt>
                  <c:pt idx="4">
                    <c:v>6.9472673453218024E-3</c:v>
                  </c:pt>
                  <c:pt idx="5">
                    <c:v>8.0732133269552728E-3</c:v>
                  </c:pt>
                  <c:pt idx="6">
                    <c:v>1.3099892934914283E-2</c:v>
                  </c:pt>
                  <c:pt idx="7">
                    <c:v>2.1933743381034907E-2</c:v>
                  </c:pt>
                </c:numCache>
              </c:numRef>
            </c:plus>
            <c:minus>
              <c:numRef>
                <c:f>Sheet1!$N$46:$U$46</c:f>
                <c:numCache>
                  <c:formatCode>General</c:formatCode>
                  <c:ptCount val="8"/>
                  <c:pt idx="0">
                    <c:v>1.5233460901119433E-2</c:v>
                  </c:pt>
                  <c:pt idx="1">
                    <c:v>4.7344191994281068E-2</c:v>
                  </c:pt>
                  <c:pt idx="2">
                    <c:v>6.7905102591764022E-3</c:v>
                  </c:pt>
                  <c:pt idx="3">
                    <c:v>6.5366807530927214E-3</c:v>
                  </c:pt>
                  <c:pt idx="4">
                    <c:v>6.9472673453218024E-3</c:v>
                  </c:pt>
                  <c:pt idx="5">
                    <c:v>8.0732133269552728E-3</c:v>
                  </c:pt>
                  <c:pt idx="6">
                    <c:v>1.3099892934914283E-2</c:v>
                  </c:pt>
                  <c:pt idx="7">
                    <c:v>2.1933743381034907E-2</c:v>
                  </c:pt>
                </c:numCache>
              </c:numRef>
            </c:minus>
          </c:errBars>
          <c:cat>
            <c:strRef>
              <c:f>Sheet1!$N$22:$T$22</c:f>
              <c:strCache>
                <c:ptCount val="7"/>
                <c:pt idx="0">
                  <c:v>P131</c:v>
                </c:pt>
                <c:pt idx="1">
                  <c:v>6B</c:v>
                </c:pt>
                <c:pt idx="2">
                  <c:v>Z9</c:v>
                </c:pt>
                <c:pt idx="3">
                  <c:v>F</c:v>
                </c:pt>
                <c:pt idx="4">
                  <c:v>H</c:v>
                </c:pt>
                <c:pt idx="5">
                  <c:v>G</c:v>
                </c:pt>
                <c:pt idx="6">
                  <c:v>I</c:v>
                </c:pt>
              </c:strCache>
            </c:strRef>
          </c:cat>
          <c:val>
            <c:numRef>
              <c:f>Sheet1!$N$23:$T$23</c:f>
              <c:numCache>
                <c:formatCode>General</c:formatCode>
                <c:ptCount val="7"/>
                <c:pt idx="0">
                  <c:v>0.17819706498951784</c:v>
                </c:pt>
                <c:pt idx="1">
                  <c:v>0.39832285115303989</c:v>
                </c:pt>
                <c:pt idx="2">
                  <c:v>0.17555169848747842</c:v>
                </c:pt>
                <c:pt idx="3">
                  <c:v>0.20576131687242794</c:v>
                </c:pt>
                <c:pt idx="4">
                  <c:v>0.19449326303456352</c:v>
                </c:pt>
                <c:pt idx="5">
                  <c:v>0.21300935203740815</c:v>
                </c:pt>
                <c:pt idx="6">
                  <c:v>0.187043105621376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7E-41C6-82BF-ABD47C63B9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921088"/>
        <c:axId val="200922624"/>
      </c:barChart>
      <c:catAx>
        <c:axId val="200921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0922624"/>
        <c:crosses val="autoZero"/>
        <c:auto val="1"/>
        <c:lblAlgn val="ctr"/>
        <c:lblOffset val="100"/>
        <c:noMultiLvlLbl val="0"/>
      </c:catAx>
      <c:valAx>
        <c:axId val="200922624"/>
        <c:scaling>
          <c:orientation val="minMax"/>
          <c:max val="0.60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0921088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L$16:$R$16</c:f>
                <c:numCache>
                  <c:formatCode>General</c:formatCode>
                  <c:ptCount val="7"/>
                  <c:pt idx="0">
                    <c:v>7.4716829204474894E-3</c:v>
                  </c:pt>
                  <c:pt idx="1">
                    <c:v>7.4310171740635525E-3</c:v>
                  </c:pt>
                  <c:pt idx="2">
                    <c:v>2.6908920508266456E-2</c:v>
                  </c:pt>
                  <c:pt idx="3">
                    <c:v>1.6532920289055703E-2</c:v>
                  </c:pt>
                  <c:pt idx="4">
                    <c:v>2.0896311750671054E-2</c:v>
                  </c:pt>
                  <c:pt idx="5">
                    <c:v>1.3787891556803078E-2</c:v>
                  </c:pt>
                  <c:pt idx="6">
                    <c:v>1.0465137364452716E-2</c:v>
                  </c:pt>
                </c:numCache>
              </c:numRef>
            </c:plus>
            <c:minus>
              <c:numRef>
                <c:f>Sheet1!$L$16:$R$16</c:f>
                <c:numCache>
                  <c:formatCode>General</c:formatCode>
                  <c:ptCount val="7"/>
                  <c:pt idx="0">
                    <c:v>7.4716829204474894E-3</c:v>
                  </c:pt>
                  <c:pt idx="1">
                    <c:v>7.4310171740635525E-3</c:v>
                  </c:pt>
                  <c:pt idx="2">
                    <c:v>2.6908920508266456E-2</c:v>
                  </c:pt>
                  <c:pt idx="3">
                    <c:v>1.6532920289055703E-2</c:v>
                  </c:pt>
                  <c:pt idx="4">
                    <c:v>2.0896311750671054E-2</c:v>
                  </c:pt>
                  <c:pt idx="5">
                    <c:v>1.3787891556803078E-2</c:v>
                  </c:pt>
                  <c:pt idx="6">
                    <c:v>1.0465137364452716E-2</c:v>
                  </c:pt>
                </c:numCache>
              </c:numRef>
            </c:minus>
          </c:errBars>
          <c:cat>
            <c:strRef>
              <c:f>Sheet1!$L$14:$R$14</c:f>
              <c:strCache>
                <c:ptCount val="7"/>
                <c:pt idx="0">
                  <c:v>P131</c:v>
                </c:pt>
                <c:pt idx="1">
                  <c:v>6B</c:v>
                </c:pt>
                <c:pt idx="2">
                  <c:v>Z9</c:v>
                </c:pt>
                <c:pt idx="3">
                  <c:v>F</c:v>
                </c:pt>
                <c:pt idx="4">
                  <c:v>H</c:v>
                </c:pt>
                <c:pt idx="5">
                  <c:v>G</c:v>
                </c:pt>
                <c:pt idx="6">
                  <c:v>I</c:v>
                </c:pt>
              </c:strCache>
            </c:strRef>
          </c:cat>
          <c:val>
            <c:numRef>
              <c:f>Sheet1!$L$15:$R$15</c:f>
              <c:numCache>
                <c:formatCode>General</c:formatCode>
                <c:ptCount val="7"/>
                <c:pt idx="0">
                  <c:v>0.33806724422442241</c:v>
                </c:pt>
                <c:pt idx="1">
                  <c:v>5.8791372334061252E-2</c:v>
                </c:pt>
                <c:pt idx="2">
                  <c:v>0.3668305204124635</c:v>
                </c:pt>
                <c:pt idx="3">
                  <c:v>0.34709292216652377</c:v>
                </c:pt>
                <c:pt idx="4">
                  <c:v>0.37185811915939498</c:v>
                </c:pt>
                <c:pt idx="5">
                  <c:v>0.31788805488511079</c:v>
                </c:pt>
                <c:pt idx="6">
                  <c:v>0.38760988662853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29-4654-A87B-A323ED79C9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235520"/>
        <c:axId val="162237056"/>
      </c:barChart>
      <c:catAx>
        <c:axId val="1622355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2237056"/>
        <c:crosses val="autoZero"/>
        <c:auto val="1"/>
        <c:lblAlgn val="ctr"/>
        <c:lblOffset val="100"/>
        <c:noMultiLvlLbl val="0"/>
      </c:catAx>
      <c:valAx>
        <c:axId val="162237056"/>
        <c:scaling>
          <c:orientation val="minMax"/>
          <c:max val="0.5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2235520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N$15:$T$15</c:f>
                <c:numCache>
                  <c:formatCode>General</c:formatCode>
                  <c:ptCount val="7"/>
                  <c:pt idx="0">
                    <c:v>1.8531586969454866E-2</c:v>
                  </c:pt>
                  <c:pt idx="1">
                    <c:v>1.124492000525955E-2</c:v>
                  </c:pt>
                  <c:pt idx="2">
                    <c:v>1.6265159042230647E-2</c:v>
                  </c:pt>
                  <c:pt idx="3">
                    <c:v>2.6263779755547643E-2</c:v>
                  </c:pt>
                  <c:pt idx="4">
                    <c:v>2.594965625781542E-2</c:v>
                  </c:pt>
                  <c:pt idx="5">
                    <c:v>8.1257996488967796E-3</c:v>
                  </c:pt>
                  <c:pt idx="6">
                    <c:v>9.4111103262449029E-3</c:v>
                  </c:pt>
                </c:numCache>
              </c:numRef>
            </c:plus>
            <c:minus>
              <c:numRef>
                <c:f>Sheet1!$N$15:$T$15</c:f>
                <c:numCache>
                  <c:formatCode>General</c:formatCode>
                  <c:ptCount val="7"/>
                  <c:pt idx="0">
                    <c:v>1.8531586969454866E-2</c:v>
                  </c:pt>
                  <c:pt idx="1">
                    <c:v>1.124492000525955E-2</c:v>
                  </c:pt>
                  <c:pt idx="2">
                    <c:v>1.6265159042230647E-2</c:v>
                  </c:pt>
                  <c:pt idx="3">
                    <c:v>2.6263779755547643E-2</c:v>
                  </c:pt>
                  <c:pt idx="4">
                    <c:v>2.594965625781542E-2</c:v>
                  </c:pt>
                  <c:pt idx="5">
                    <c:v>8.1257996488967796E-3</c:v>
                  </c:pt>
                  <c:pt idx="6">
                    <c:v>9.4111103262449029E-3</c:v>
                  </c:pt>
                </c:numCache>
              </c:numRef>
            </c:minus>
          </c:errBars>
          <c:cat>
            <c:strRef>
              <c:f>Sheet1!$N$13:$T$13</c:f>
              <c:strCache>
                <c:ptCount val="7"/>
                <c:pt idx="0">
                  <c:v>131</c:v>
                </c:pt>
                <c:pt idx="1">
                  <c:v>6b</c:v>
                </c:pt>
                <c:pt idx="2">
                  <c:v>z9</c:v>
                </c:pt>
                <c:pt idx="3">
                  <c:v>F</c:v>
                </c:pt>
                <c:pt idx="4">
                  <c:v>H</c:v>
                </c:pt>
                <c:pt idx="5">
                  <c:v>G</c:v>
                </c:pt>
                <c:pt idx="6">
                  <c:v>I</c:v>
                </c:pt>
              </c:strCache>
            </c:strRef>
          </c:cat>
          <c:val>
            <c:numRef>
              <c:f>Sheet1!$N$14:$T$14</c:f>
              <c:numCache>
                <c:formatCode>General</c:formatCode>
                <c:ptCount val="7"/>
                <c:pt idx="0">
                  <c:v>0.34519331661559943</c:v>
                </c:pt>
                <c:pt idx="1">
                  <c:v>7.6814798395729023E-2</c:v>
                </c:pt>
                <c:pt idx="2">
                  <c:v>0.36426857849379024</c:v>
                </c:pt>
                <c:pt idx="3">
                  <c:v>0.34956388605363276</c:v>
                </c:pt>
                <c:pt idx="4">
                  <c:v>0.31724219634569401</c:v>
                </c:pt>
                <c:pt idx="5">
                  <c:v>0.31632065923791025</c:v>
                </c:pt>
                <c:pt idx="6">
                  <c:v>0.31971869829012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B7-4F2D-9028-62EE59B38C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3806592"/>
        <c:axId val="203808128"/>
      </c:barChart>
      <c:catAx>
        <c:axId val="2038065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3808128"/>
        <c:crosses val="autoZero"/>
        <c:auto val="1"/>
        <c:lblAlgn val="ctr"/>
        <c:lblOffset val="100"/>
        <c:noMultiLvlLbl val="0"/>
      </c:catAx>
      <c:valAx>
        <c:axId val="203808128"/>
        <c:scaling>
          <c:orientation val="minMax"/>
          <c:max val="0.4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380659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L$21:$R$21</c:f>
                <c:numCache>
                  <c:formatCode>General</c:formatCode>
                  <c:ptCount val="7"/>
                  <c:pt idx="0">
                    <c:v>2.7255766403644008</c:v>
                  </c:pt>
                  <c:pt idx="1">
                    <c:v>1.6224349022208717</c:v>
                  </c:pt>
                  <c:pt idx="2">
                    <c:v>3.8788451153160364</c:v>
                  </c:pt>
                  <c:pt idx="3">
                    <c:v>6.9558670030733518</c:v>
                  </c:pt>
                  <c:pt idx="4">
                    <c:v>2.6076103569381512</c:v>
                  </c:pt>
                  <c:pt idx="5">
                    <c:v>2.4897741400799864</c:v>
                  </c:pt>
                  <c:pt idx="6">
                    <c:v>3.0198090047679966</c:v>
                  </c:pt>
                </c:numCache>
              </c:numRef>
            </c:plus>
            <c:minus>
              <c:numRef>
                <c:f>Sheet1!$L$21:$R$21</c:f>
                <c:numCache>
                  <c:formatCode>General</c:formatCode>
                  <c:ptCount val="7"/>
                  <c:pt idx="0">
                    <c:v>2.7255766403644008</c:v>
                  </c:pt>
                  <c:pt idx="1">
                    <c:v>1.6224349022208717</c:v>
                  </c:pt>
                  <c:pt idx="2">
                    <c:v>3.8788451153160364</c:v>
                  </c:pt>
                  <c:pt idx="3">
                    <c:v>6.9558670030733518</c:v>
                  </c:pt>
                  <c:pt idx="4">
                    <c:v>2.6076103569381512</c:v>
                  </c:pt>
                  <c:pt idx="5">
                    <c:v>2.4897741400799864</c:v>
                  </c:pt>
                  <c:pt idx="6">
                    <c:v>3.0198090047679966</c:v>
                  </c:pt>
                </c:numCache>
              </c:numRef>
            </c:minus>
          </c:errBars>
          <c:cat>
            <c:strRef>
              <c:f>Sheet1!$L$19:$R$19</c:f>
              <c:strCache>
                <c:ptCount val="7"/>
                <c:pt idx="0">
                  <c:v>P131</c:v>
                </c:pt>
                <c:pt idx="1">
                  <c:v>6b</c:v>
                </c:pt>
                <c:pt idx="2">
                  <c:v>z9</c:v>
                </c:pt>
                <c:pt idx="3">
                  <c:v>F</c:v>
                </c:pt>
                <c:pt idx="4">
                  <c:v>H</c:v>
                </c:pt>
                <c:pt idx="5">
                  <c:v>G</c:v>
                </c:pt>
                <c:pt idx="6">
                  <c:v>I</c:v>
                </c:pt>
              </c:strCache>
            </c:strRef>
          </c:cat>
          <c:val>
            <c:numRef>
              <c:f>Sheet1!$L$20:$R$20</c:f>
              <c:numCache>
                <c:formatCode>General</c:formatCode>
                <c:ptCount val="7"/>
                <c:pt idx="0">
                  <c:v>25.417466666666666</c:v>
                </c:pt>
                <c:pt idx="1">
                  <c:v>6.575622222222222</c:v>
                </c:pt>
                <c:pt idx="2">
                  <c:v>28.304388888888887</c:v>
                </c:pt>
                <c:pt idx="3">
                  <c:v>27.962422222222219</c:v>
                </c:pt>
                <c:pt idx="4">
                  <c:v>26.771111111111114</c:v>
                </c:pt>
                <c:pt idx="5">
                  <c:v>20.54441111111111</c:v>
                </c:pt>
                <c:pt idx="6">
                  <c:v>23.432044444444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92-455F-9171-7A91E366EE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3735424"/>
        <c:axId val="203736960"/>
      </c:barChart>
      <c:catAx>
        <c:axId val="2037354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3736960"/>
        <c:crosses val="autoZero"/>
        <c:auto val="1"/>
        <c:lblAlgn val="ctr"/>
        <c:lblOffset val="100"/>
        <c:noMultiLvlLbl val="0"/>
      </c:catAx>
      <c:valAx>
        <c:axId val="203736960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203735424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7-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eg"/><Relationship Id="rId18" Type="http://schemas.microsoft.com/office/2007/relationships/hdphoto" Target="../media/hdphoto1.wdp"/><Relationship Id="rId26" Type="http://schemas.microsoft.com/office/2007/relationships/hdphoto" Target="../media/hdphoto5.wdp"/><Relationship Id="rId39" Type="http://schemas.microsoft.com/office/2007/relationships/hdphoto" Target="../media/hdphoto10.wdp"/><Relationship Id="rId21" Type="http://schemas.openxmlformats.org/officeDocument/2006/relationships/image" Target="../media/image17.png"/><Relationship Id="rId34" Type="http://schemas.openxmlformats.org/officeDocument/2006/relationships/image" Target="../media/image22.jpeg"/><Relationship Id="rId42" Type="http://schemas.openxmlformats.org/officeDocument/2006/relationships/image" Target="../media/image26.jpeg"/><Relationship Id="rId47" Type="http://schemas.microsoft.com/office/2007/relationships/hdphoto" Target="../media/hdphoto14.wdp"/><Relationship Id="rId50" Type="http://schemas.openxmlformats.org/officeDocument/2006/relationships/image" Target="../media/image30.jpeg"/><Relationship Id="rId55" Type="http://schemas.microsoft.com/office/2007/relationships/hdphoto" Target="../media/hdphoto18.wdp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6" Type="http://schemas.openxmlformats.org/officeDocument/2006/relationships/chart" Target="../charts/chart1.xml"/><Relationship Id="rId29" Type="http://schemas.openxmlformats.org/officeDocument/2006/relationships/image" Target="../media/image21.png"/><Relationship Id="rId11" Type="http://schemas.openxmlformats.org/officeDocument/2006/relationships/image" Target="../media/image10.jpeg"/><Relationship Id="rId24" Type="http://schemas.microsoft.com/office/2007/relationships/hdphoto" Target="../media/hdphoto4.wdp"/><Relationship Id="rId32" Type="http://schemas.openxmlformats.org/officeDocument/2006/relationships/chart" Target="../charts/chart3.xml"/><Relationship Id="rId37" Type="http://schemas.microsoft.com/office/2007/relationships/hdphoto" Target="../media/hdphoto9.wdp"/><Relationship Id="rId40" Type="http://schemas.openxmlformats.org/officeDocument/2006/relationships/image" Target="../media/image25.jpeg"/><Relationship Id="rId45" Type="http://schemas.microsoft.com/office/2007/relationships/hdphoto" Target="../media/hdphoto13.wdp"/><Relationship Id="rId53" Type="http://schemas.microsoft.com/office/2007/relationships/hdphoto" Target="../media/hdphoto17.wdp"/><Relationship Id="rId58" Type="http://schemas.openxmlformats.org/officeDocument/2006/relationships/image" Target="../media/image34.jpeg"/><Relationship Id="rId5" Type="http://schemas.openxmlformats.org/officeDocument/2006/relationships/image" Target="../media/image4.jpeg"/><Relationship Id="rId61" Type="http://schemas.microsoft.com/office/2007/relationships/hdphoto" Target="../media/hdphoto21.wdp"/><Relationship Id="rId19" Type="http://schemas.openxmlformats.org/officeDocument/2006/relationships/image" Target="../media/image16.png"/><Relationship Id="rId14" Type="http://schemas.openxmlformats.org/officeDocument/2006/relationships/image" Target="../media/image13.jpeg"/><Relationship Id="rId22" Type="http://schemas.microsoft.com/office/2007/relationships/hdphoto" Target="../media/hdphoto3.wdp"/><Relationship Id="rId27" Type="http://schemas.openxmlformats.org/officeDocument/2006/relationships/image" Target="../media/image20.png"/><Relationship Id="rId30" Type="http://schemas.microsoft.com/office/2007/relationships/hdphoto" Target="../media/hdphoto7.wdp"/><Relationship Id="rId35" Type="http://schemas.microsoft.com/office/2007/relationships/hdphoto" Target="../media/hdphoto8.wdp"/><Relationship Id="rId43" Type="http://schemas.microsoft.com/office/2007/relationships/hdphoto" Target="../media/hdphoto12.wdp"/><Relationship Id="rId48" Type="http://schemas.openxmlformats.org/officeDocument/2006/relationships/image" Target="../media/image29.jpeg"/><Relationship Id="rId56" Type="http://schemas.openxmlformats.org/officeDocument/2006/relationships/image" Target="../media/image33.jpeg"/><Relationship Id="rId8" Type="http://schemas.openxmlformats.org/officeDocument/2006/relationships/image" Target="../media/image7.jpeg"/><Relationship Id="rId51" Type="http://schemas.microsoft.com/office/2007/relationships/hdphoto" Target="../media/hdphoto16.wdp"/><Relationship Id="rId3" Type="http://schemas.openxmlformats.org/officeDocument/2006/relationships/image" Target="../media/image2.jpeg"/><Relationship Id="rId12" Type="http://schemas.openxmlformats.org/officeDocument/2006/relationships/image" Target="../media/image11.jpeg"/><Relationship Id="rId17" Type="http://schemas.openxmlformats.org/officeDocument/2006/relationships/image" Target="../media/image15.png"/><Relationship Id="rId25" Type="http://schemas.openxmlformats.org/officeDocument/2006/relationships/image" Target="../media/image19.png"/><Relationship Id="rId33" Type="http://schemas.openxmlformats.org/officeDocument/2006/relationships/chart" Target="../charts/chart4.xml"/><Relationship Id="rId38" Type="http://schemas.openxmlformats.org/officeDocument/2006/relationships/image" Target="../media/image24.jpeg"/><Relationship Id="rId46" Type="http://schemas.openxmlformats.org/officeDocument/2006/relationships/image" Target="../media/image28.jpeg"/><Relationship Id="rId59" Type="http://schemas.microsoft.com/office/2007/relationships/hdphoto" Target="../media/hdphoto20.wdp"/><Relationship Id="rId20" Type="http://schemas.microsoft.com/office/2007/relationships/hdphoto" Target="../media/hdphoto2.wdp"/><Relationship Id="rId41" Type="http://schemas.microsoft.com/office/2007/relationships/hdphoto" Target="../media/hdphoto11.wdp"/><Relationship Id="rId54" Type="http://schemas.openxmlformats.org/officeDocument/2006/relationships/image" Target="../media/image3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5" Type="http://schemas.openxmlformats.org/officeDocument/2006/relationships/image" Target="../media/image14.jpeg"/><Relationship Id="rId23" Type="http://schemas.openxmlformats.org/officeDocument/2006/relationships/image" Target="../media/image18.png"/><Relationship Id="rId28" Type="http://schemas.microsoft.com/office/2007/relationships/hdphoto" Target="../media/hdphoto6.wdp"/><Relationship Id="rId36" Type="http://schemas.openxmlformats.org/officeDocument/2006/relationships/image" Target="../media/image23.jpeg"/><Relationship Id="rId49" Type="http://schemas.microsoft.com/office/2007/relationships/hdphoto" Target="../media/hdphoto15.wdp"/><Relationship Id="rId57" Type="http://schemas.microsoft.com/office/2007/relationships/hdphoto" Target="../media/hdphoto19.wdp"/><Relationship Id="rId10" Type="http://schemas.openxmlformats.org/officeDocument/2006/relationships/image" Target="../media/image9.jpeg"/><Relationship Id="rId31" Type="http://schemas.openxmlformats.org/officeDocument/2006/relationships/chart" Target="../charts/chart2.xml"/><Relationship Id="rId44" Type="http://schemas.openxmlformats.org/officeDocument/2006/relationships/image" Target="../media/image27.jpeg"/><Relationship Id="rId52" Type="http://schemas.openxmlformats.org/officeDocument/2006/relationships/image" Target="../media/image31.jpeg"/><Relationship Id="rId60" Type="http://schemas.openxmlformats.org/officeDocument/2006/relationships/image" Target="../media/image35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组合 38"/>
          <p:cNvGrpSpPr/>
          <p:nvPr/>
        </p:nvGrpSpPr>
        <p:grpSpPr>
          <a:xfrm>
            <a:off x="168187" y="681298"/>
            <a:ext cx="3879212" cy="1487227"/>
            <a:chOff x="168187" y="681298"/>
            <a:chExt cx="3879212" cy="1487227"/>
          </a:xfrm>
        </p:grpSpPr>
        <p:sp>
          <p:nvSpPr>
            <p:cNvPr id="60" name="矩形 59"/>
            <p:cNvSpPr/>
            <p:nvPr/>
          </p:nvSpPr>
          <p:spPr>
            <a:xfrm rot="18908584">
              <a:off x="1442306" y="681298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2" name="Picture 10" descr="C:\Users\12466\Desktop\点突变CFW第三次\FCM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817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" name="Picture 11" descr="C:\Users\12466\Desktop\点突变CFW第三次\G CM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45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12" descr="C:\Users\12466\Desktop\点突变CFW第三次\H CM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981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13" descr="C:\Users\12466\Desktop\点突变CFW第三次\I CM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309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2" descr="C:\Users\12466\Desktop\点突变CFW第三次\F CFW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V="1">
              <a:off x="200817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23" descr="C:\Users\12466\Desktop\点突变CFW第三次\G CFW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981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4" descr="C:\Users\12466\Desktop\点突变CFW第三次\H CFW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145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25" descr="C:\Users\12466\Desktop\点突变CFW第三次\I CFW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309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矩形 9"/>
            <p:cNvSpPr/>
            <p:nvPr/>
          </p:nvSpPr>
          <p:spPr>
            <a:xfrm rot="18908584">
              <a:off x="2039221" y="88933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1" name="矩形 10"/>
            <p:cNvSpPr/>
            <p:nvPr/>
          </p:nvSpPr>
          <p:spPr>
            <a:xfrm rot="18908584">
              <a:off x="3018662" y="88933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12" name="矩形 11"/>
            <p:cNvSpPr/>
            <p:nvPr/>
          </p:nvSpPr>
          <p:spPr>
            <a:xfrm rot="18908584">
              <a:off x="2516267" y="88933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13" name="矩形 12"/>
            <p:cNvSpPr/>
            <p:nvPr/>
          </p:nvSpPr>
          <p:spPr>
            <a:xfrm rot="18908584">
              <a:off x="3497248" y="88933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254360" y="1277777"/>
              <a:ext cx="338554" cy="40422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M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201020" y="1773300"/>
              <a:ext cx="338554" cy="40422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FW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030" name="Picture 6" descr="C:\Users\12466\Desktop\点突变CFW第三次\6b cm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489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C:\Users\12466\Desktop\点突变CFW第三次\Z9 cm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1653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C:\Users\12466\Desktop\点突变CFW第三次\6b cfw.jp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489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C:\Users\12466\Desktop\点突变CFW第三次\Z9cfw.jpg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1653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 descr="C:\Users\12466\Desktop\点突变CFW第三次\131cfw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252" y="1700525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8" name="矩形 57"/>
            <p:cNvSpPr/>
            <p:nvPr/>
          </p:nvSpPr>
          <p:spPr>
            <a:xfrm rot="18908584">
              <a:off x="640390" y="923259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59" name="矩形 58"/>
            <p:cNvSpPr/>
            <p:nvPr/>
          </p:nvSpPr>
          <p:spPr>
            <a:xfrm rot="18908584">
              <a:off x="1026351" y="812454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pic>
          <p:nvPicPr>
            <p:cNvPr id="1035" name="Picture 11" descr="C:\Users\12466\Desktop\点突变CFW第三次\131cm.jpg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252" y="1195010"/>
              <a:ext cx="468000" cy="4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38" name="组合 37"/>
          <p:cNvGrpSpPr/>
          <p:nvPr/>
        </p:nvGrpSpPr>
        <p:grpSpPr>
          <a:xfrm>
            <a:off x="3924589" y="459114"/>
            <a:ext cx="2387619" cy="2133709"/>
            <a:chOff x="3924589" y="459114"/>
            <a:chExt cx="2387619" cy="2133709"/>
          </a:xfrm>
        </p:grpSpPr>
        <p:sp>
          <p:nvSpPr>
            <p:cNvPr id="18" name="TextBox 17"/>
            <p:cNvSpPr txBox="1"/>
            <p:nvPr/>
          </p:nvSpPr>
          <p:spPr>
            <a:xfrm flipV="1">
              <a:off x="3924589" y="527946"/>
              <a:ext cx="338554" cy="164333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Growth reduction </a:t>
              </a:r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rate </a:t>
              </a:r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(%)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040279" y="990780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040279" y="2017254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040279" y="1504017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040279" y="47754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6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8908584">
              <a:off x="4241308" y="2135270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24" name="矩形 23"/>
            <p:cNvSpPr/>
            <p:nvPr/>
          </p:nvSpPr>
          <p:spPr>
            <a:xfrm rot="18908584">
              <a:off x="4220524" y="2246075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25" name="矩形 24"/>
            <p:cNvSpPr/>
            <p:nvPr/>
          </p:nvSpPr>
          <p:spPr>
            <a:xfrm rot="18908584">
              <a:off x="4135041" y="2361991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8908584">
              <a:off x="4909031" y="21691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32" name="矩形 31"/>
            <p:cNvSpPr/>
            <p:nvPr/>
          </p:nvSpPr>
          <p:spPr>
            <a:xfrm rot="18908584">
              <a:off x="5425903" y="21691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33" name="矩形 32"/>
            <p:cNvSpPr/>
            <p:nvPr/>
          </p:nvSpPr>
          <p:spPr>
            <a:xfrm rot="18908584">
              <a:off x="5169511" y="21691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34" name="矩形 33"/>
            <p:cNvSpPr/>
            <p:nvPr/>
          </p:nvSpPr>
          <p:spPr>
            <a:xfrm rot="18908584">
              <a:off x="5666558" y="21691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graphicFrame>
          <p:nvGraphicFramePr>
            <p:cNvPr id="47" name="图表 4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92883498"/>
                </p:ext>
              </p:extLst>
            </p:nvPr>
          </p:nvGraphicFramePr>
          <p:xfrm>
            <a:off x="4260208" y="459114"/>
            <a:ext cx="2052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61" name="TextBox 60"/>
            <p:cNvSpPr txBox="1"/>
            <p:nvPr/>
          </p:nvSpPr>
          <p:spPr>
            <a:xfrm>
              <a:off x="4394138" y="1432783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903390" y="1472145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169446" y="1390823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410948" y="140905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661764" y="137384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922781" y="141839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645801" y="797785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0" name="TextBox 169"/>
          <p:cNvSpPr txBox="1"/>
          <p:nvPr/>
        </p:nvSpPr>
        <p:spPr>
          <a:xfrm>
            <a:off x="128474" y="395290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3783621" y="395290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128474" y="2698656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3311272" y="2698656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128474" y="464536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3311272" y="464536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128474" y="702826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G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3311272" y="702826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788503" y="2521534"/>
            <a:ext cx="2164338" cy="2246167"/>
            <a:chOff x="788503" y="2521534"/>
            <a:chExt cx="2164338" cy="2246167"/>
          </a:xfrm>
        </p:grpSpPr>
        <p:pic>
          <p:nvPicPr>
            <p:cNvPr id="35" name="Picture 8" descr="C:\Users\12466\Desktop\点突变水稻\131附图.jpg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aturation sat="30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5574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" name="Picture 9" descr="C:\Users\12466\Desktop\点突变水稻\6b附图.jpg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65033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7" name="Picture 10" descr="C:\Users\12466\Desktop\点突变水稻\Z9 附图.jpg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34492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9" name="Picture 15" descr="C:\Users\12466\Desktop\点突变水稻\F.jpg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3951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0" name="Picture 16" descr="C:\Users\12466\Desktop\点突变水稻\G.jpg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3410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1" name="Picture 17" descr="C:\Users\12466\Desktop\点突变水稻\H.jpg"/>
            <p:cNvPicPr>
              <a:picLocks noChangeAspect="1" noChangeArrowheads="1"/>
            </p:cNvPicPr>
            <p:nvPr/>
          </p:nvPicPr>
          <p:blipFill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2869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2" name="Picture 18" descr="C:\Users\12466\Desktop\点突变水稻\I.jpg"/>
            <p:cNvPicPr>
              <a:picLocks noChangeAspect="1" noChangeArrowheads="1"/>
            </p:cNvPicPr>
            <p:nvPr/>
          </p:nvPicPr>
          <p:blipFill>
            <a:blip r:embed="rId29" cstate="print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09650" y="3027013"/>
              <a:ext cx="139810" cy="154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0" name="矩形 109"/>
            <p:cNvSpPr/>
            <p:nvPr/>
          </p:nvSpPr>
          <p:spPr>
            <a:xfrm rot="18908584">
              <a:off x="788503" y="2763495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111" name="矩形 110"/>
            <p:cNvSpPr/>
            <p:nvPr/>
          </p:nvSpPr>
          <p:spPr>
            <a:xfrm rot="18908584">
              <a:off x="1017614" y="2652690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112" name="矩形 111"/>
            <p:cNvSpPr/>
            <p:nvPr/>
          </p:nvSpPr>
          <p:spPr>
            <a:xfrm rot="18908584">
              <a:off x="1202305" y="2521534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13" name="矩形 112"/>
            <p:cNvSpPr/>
            <p:nvPr/>
          </p:nvSpPr>
          <p:spPr>
            <a:xfrm rot="18908584">
              <a:off x="1586938" y="2729575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14" name="矩形 113"/>
            <p:cNvSpPr/>
            <p:nvPr/>
          </p:nvSpPr>
          <p:spPr>
            <a:xfrm rot="18908584">
              <a:off x="2131592" y="2729575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115" name="矩形 114"/>
            <p:cNvSpPr/>
            <p:nvPr/>
          </p:nvSpPr>
          <p:spPr>
            <a:xfrm rot="18908584">
              <a:off x="1871502" y="2729575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116" name="矩形 115"/>
            <p:cNvSpPr/>
            <p:nvPr/>
          </p:nvSpPr>
          <p:spPr>
            <a:xfrm rot="18908584">
              <a:off x="2402690" y="2729575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564557" y="4521480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Rice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3697250" y="2754086"/>
            <a:ext cx="2521804" cy="1935012"/>
            <a:chOff x="3697250" y="2754086"/>
            <a:chExt cx="2521804" cy="1935012"/>
          </a:xfrm>
        </p:grpSpPr>
        <p:graphicFrame>
          <p:nvGraphicFramePr>
            <p:cNvPr id="205" name="图表 20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7931693"/>
                </p:ext>
              </p:extLst>
            </p:nvPr>
          </p:nvGraphicFramePr>
          <p:xfrm>
            <a:off x="4059054" y="2908600"/>
            <a:ext cx="216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1"/>
            </a:graphicData>
          </a:graphic>
        </p:graphicFrame>
        <p:sp>
          <p:nvSpPr>
            <p:cNvPr id="140" name="矩形 139"/>
            <p:cNvSpPr/>
            <p:nvPr/>
          </p:nvSpPr>
          <p:spPr>
            <a:xfrm rot="18908584">
              <a:off x="4055552" y="4235609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141" name="矩形 140"/>
            <p:cNvSpPr/>
            <p:nvPr/>
          </p:nvSpPr>
          <p:spPr>
            <a:xfrm rot="18908584">
              <a:off x="4048739" y="4351494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142" name="矩形 141"/>
            <p:cNvSpPr/>
            <p:nvPr/>
          </p:nvSpPr>
          <p:spPr>
            <a:xfrm rot="18908584">
              <a:off x="3985313" y="4458266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43" name="矩形 142"/>
            <p:cNvSpPr/>
            <p:nvPr/>
          </p:nvSpPr>
          <p:spPr>
            <a:xfrm rot="18908584">
              <a:off x="4785718" y="425936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44" name="矩形 143"/>
            <p:cNvSpPr/>
            <p:nvPr/>
          </p:nvSpPr>
          <p:spPr>
            <a:xfrm rot="18908584">
              <a:off x="5319524" y="425936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145" name="矩形 144"/>
            <p:cNvSpPr/>
            <p:nvPr/>
          </p:nvSpPr>
          <p:spPr>
            <a:xfrm rot="18908584">
              <a:off x="5054665" y="425936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146" name="矩形 145"/>
            <p:cNvSpPr/>
            <p:nvPr/>
          </p:nvSpPr>
          <p:spPr>
            <a:xfrm rot="18908584">
              <a:off x="5585580" y="4259369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 flipV="1">
              <a:off x="3697250" y="2754086"/>
              <a:ext cx="338554" cy="152874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R</a:t>
              </a:r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elative </a:t>
              </a:r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esion area (%)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215042" y="320280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4488959" y="385158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757238" y="311000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5015645" y="316859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5290647" y="3109108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5555969" y="3255834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5830632" y="309806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3848856" y="3620816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r>
                <a:rPr lang="en-US" altLang="zh-CN" sz="9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3848856" y="4073104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3848856" y="3852040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1</a:t>
              </a:r>
              <a:r>
                <a:rPr lang="en-US" altLang="zh-CN" sz="9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3848856" y="3379432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3</a:t>
              </a:r>
              <a:r>
                <a:rPr lang="en-US" altLang="zh-CN" sz="9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3848856" y="3148208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</a:t>
              </a:r>
              <a:r>
                <a:rPr lang="en-US" altLang="zh-CN" sz="9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3848856" y="2916984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5</a:t>
              </a:r>
              <a:r>
                <a:rPr lang="en-US" altLang="zh-CN" sz="9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4781915" y="2884108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Rice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3683025" y="4763109"/>
            <a:ext cx="2496701" cy="2110605"/>
            <a:chOff x="3683025" y="4763109"/>
            <a:chExt cx="2496701" cy="2110605"/>
          </a:xfrm>
        </p:grpSpPr>
        <p:graphicFrame>
          <p:nvGraphicFramePr>
            <p:cNvPr id="106" name="图表 10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22193420"/>
                </p:ext>
              </p:extLst>
            </p:nvPr>
          </p:nvGraphicFramePr>
          <p:xfrm>
            <a:off x="4019726" y="4915175"/>
            <a:ext cx="216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2"/>
            </a:graphicData>
          </a:graphic>
        </p:graphicFrame>
        <p:sp>
          <p:nvSpPr>
            <p:cNvPr id="107" name="TextBox 106"/>
            <p:cNvSpPr txBox="1"/>
            <p:nvPr/>
          </p:nvSpPr>
          <p:spPr>
            <a:xfrm>
              <a:off x="3814021" y="5609382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814021" y="6276504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814021" y="5942943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1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3814021" y="5275821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3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3814021" y="4942260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 flipV="1">
              <a:off x="3683025" y="4944366"/>
              <a:ext cx="338554" cy="141040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R</a:t>
              </a:r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elative </a:t>
              </a:r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esion area (%)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174061" y="4993099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4444999" y="5905871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4720452" y="4944366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957521" y="4952833"/>
              <a:ext cx="3514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5255280" y="5041775"/>
              <a:ext cx="2676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5500817" y="5117972"/>
              <a:ext cx="2676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5780222" y="5109511"/>
              <a:ext cx="2676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矩形 190"/>
            <p:cNvSpPr/>
            <p:nvPr/>
          </p:nvSpPr>
          <p:spPr>
            <a:xfrm rot="18908584">
              <a:off x="4015327" y="6416161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192" name="矩形 191"/>
            <p:cNvSpPr/>
            <p:nvPr/>
          </p:nvSpPr>
          <p:spPr>
            <a:xfrm rot="18908584">
              <a:off x="4000894" y="6526966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193" name="矩形 192"/>
            <p:cNvSpPr/>
            <p:nvPr/>
          </p:nvSpPr>
          <p:spPr>
            <a:xfrm rot="18908584">
              <a:off x="3951184" y="6642882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94" name="矩形 193"/>
            <p:cNvSpPr/>
            <p:nvPr/>
          </p:nvSpPr>
          <p:spPr>
            <a:xfrm rot="18908584">
              <a:off x="4726443" y="645008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95" name="矩形 194"/>
            <p:cNvSpPr/>
            <p:nvPr/>
          </p:nvSpPr>
          <p:spPr>
            <a:xfrm rot="18908584">
              <a:off x="5258133" y="645008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196" name="矩形 195"/>
            <p:cNvSpPr/>
            <p:nvPr/>
          </p:nvSpPr>
          <p:spPr>
            <a:xfrm rot="18908584">
              <a:off x="4994332" y="645008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197" name="矩形 196"/>
            <p:cNvSpPr/>
            <p:nvPr/>
          </p:nvSpPr>
          <p:spPr>
            <a:xfrm rot="18908584">
              <a:off x="5533714" y="645008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4781915" y="4763109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Barley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3666090" y="7054454"/>
            <a:ext cx="2507746" cy="2062869"/>
            <a:chOff x="3666090" y="7054454"/>
            <a:chExt cx="2507746" cy="2062869"/>
          </a:xfrm>
        </p:grpSpPr>
        <p:graphicFrame>
          <p:nvGraphicFramePr>
            <p:cNvPr id="69" name="图表 6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64778428"/>
                </p:ext>
              </p:extLst>
            </p:nvPr>
          </p:nvGraphicFramePr>
          <p:xfrm>
            <a:off x="4013836" y="7152488"/>
            <a:ext cx="2160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3"/>
            </a:graphicData>
          </a:graphic>
        </p:graphicFrame>
        <p:sp>
          <p:nvSpPr>
            <p:cNvPr id="84" name="TextBox 83"/>
            <p:cNvSpPr txBox="1"/>
            <p:nvPr/>
          </p:nvSpPr>
          <p:spPr>
            <a:xfrm>
              <a:off x="3786567" y="7838710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786567" y="8505832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786567" y="8172271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1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786567" y="7505149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3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786567" y="7171588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40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 flipV="1">
              <a:off x="3666090" y="7324394"/>
              <a:ext cx="338554" cy="11048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Lesion </a:t>
              </a:r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area (mm</a:t>
              </a:r>
              <a:r>
                <a:rPr lang="en-US" altLang="zh-CN" sz="1000" baseline="30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</a:t>
              </a:r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)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4174546" y="750087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445644" y="8165801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703926" y="7371741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4974864" y="7274255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245802" y="7460523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5508273" y="7672192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5753809" y="7553820"/>
              <a:ext cx="3116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de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矩形 197"/>
            <p:cNvSpPr/>
            <p:nvPr/>
          </p:nvSpPr>
          <p:spPr>
            <a:xfrm rot="18908584">
              <a:off x="3997335" y="8659770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199" name="矩形 198"/>
            <p:cNvSpPr/>
            <p:nvPr/>
          </p:nvSpPr>
          <p:spPr>
            <a:xfrm rot="18908584">
              <a:off x="3982902" y="8770575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200" name="矩形 199"/>
            <p:cNvSpPr/>
            <p:nvPr/>
          </p:nvSpPr>
          <p:spPr>
            <a:xfrm rot="18908584">
              <a:off x="3933192" y="8886491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201" name="矩形 200"/>
            <p:cNvSpPr/>
            <p:nvPr/>
          </p:nvSpPr>
          <p:spPr>
            <a:xfrm rot="18908584">
              <a:off x="4717976" y="86936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202" name="矩形 201"/>
            <p:cNvSpPr/>
            <p:nvPr/>
          </p:nvSpPr>
          <p:spPr>
            <a:xfrm rot="18908584">
              <a:off x="5260249" y="86936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203" name="矩形 202"/>
            <p:cNvSpPr/>
            <p:nvPr/>
          </p:nvSpPr>
          <p:spPr>
            <a:xfrm rot="18908584">
              <a:off x="4986923" y="86936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204" name="矩形 203"/>
            <p:cNvSpPr/>
            <p:nvPr/>
          </p:nvSpPr>
          <p:spPr>
            <a:xfrm rot="18908584">
              <a:off x="5534772" y="8693690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4781915" y="7054454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Barley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788497" y="4978190"/>
            <a:ext cx="2155871" cy="1945614"/>
            <a:chOff x="788497" y="4978190"/>
            <a:chExt cx="2155871" cy="1945614"/>
          </a:xfrm>
        </p:grpSpPr>
        <p:pic>
          <p:nvPicPr>
            <p:cNvPr id="100" name="Picture 44" descr="C:\Users\12466\Desktop\新建文件夹 (2)\喷接\F.jpg"/>
            <p:cNvPicPr>
              <a:picLocks noChangeAspect="1" noChangeArrowheads="1"/>
            </p:cNvPicPr>
            <p:nvPr/>
          </p:nvPicPr>
          <p:blipFill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saturation sat="40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0066" y="5472306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1" name="Picture 45" descr="C:\Users\12466\Desktop\新建文件夹 (2)\喷接\G.jpg"/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saturation sat="40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39079" y="5472306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" name="Picture 46" descr="C:\Users\12466\Desktop\新建文件夹 (2)\喷接\H.jpg"/>
            <p:cNvPicPr>
              <a:picLocks noChangeAspect="1" noChangeArrowheads="1"/>
            </p:cNvPicPr>
            <p:nvPr/>
          </p:nvPicPr>
          <p:blipFill>
            <a:blip r:embed="rId38" cstate="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saturation sat="40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8092" y="5473402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" name="Picture 47" descr="C:\Users\12466\Desktop\新建文件夹 (2)\喷接\I.jpg"/>
            <p:cNvPicPr>
              <a:picLocks noChangeAspect="1" noChangeArrowheads="1"/>
            </p:cNvPicPr>
            <p:nvPr/>
          </p:nvPicPr>
          <p:blipFill>
            <a:blip r:embed="rId40" cstate="print">
              <a:extLst>
                <a:ext uri="{BEBA8EAE-BF5A-486C-A8C5-ECC9F3942E4B}">
                  <a14:imgProps xmlns:a14="http://schemas.microsoft.com/office/drawing/2010/main">
                    <a14:imgLayer r:embed="rId41">
                      <a14:imgEffect>
                        <a14:saturation sat="40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7103" y="5472306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" name="Picture 2" descr="C:\Users\12466\Desktop\点突变大麦\喷接\131附图.jpg"/>
            <p:cNvPicPr>
              <a:picLocks noChangeAspect="1" noChangeArrowheads="1"/>
            </p:cNvPicPr>
            <p:nvPr/>
          </p:nvPicPr>
          <p:blipFill>
            <a:blip r:embed="rId42" cstate="print">
              <a:extLst>
                <a:ext uri="{BEBA8EAE-BF5A-486C-A8C5-ECC9F3942E4B}">
                  <a14:imgProps xmlns:a14="http://schemas.microsoft.com/office/drawing/2010/main">
                    <a14:imgLayer r:embed="rId4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3027" y="5477916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5" name="Picture 5" descr="C:\Users\12466\Desktop\点突变大麦\喷接\Z9附图.jpg"/>
            <p:cNvPicPr>
              <a:picLocks noChangeAspect="1" noChangeArrowheads="1"/>
            </p:cNvPicPr>
            <p:nvPr/>
          </p:nvPicPr>
          <p:blipFill>
            <a:blip r:embed="rId44" cstate="print">
              <a:extLst>
                <a:ext uri="{BEBA8EAE-BF5A-486C-A8C5-ECC9F3942E4B}">
                  <a14:imgProps xmlns:a14="http://schemas.microsoft.com/office/drawing/2010/main">
                    <a14:imgLayer r:embed="rId4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01053" y="5472305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" name="Picture 7" descr="C:\Users\12466\Desktop\点突变大麦\喷接\6b附图.jpg"/>
            <p:cNvPicPr>
              <a:picLocks noChangeAspect="1" noChangeArrowheads="1"/>
            </p:cNvPicPr>
            <p:nvPr/>
          </p:nvPicPr>
          <p:blipFill>
            <a:blip r:embed="rId46" cstate="print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2040" y="5485221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7" name="矩形 166"/>
            <p:cNvSpPr/>
            <p:nvPr/>
          </p:nvSpPr>
          <p:spPr>
            <a:xfrm rot="18908584">
              <a:off x="788497" y="5209991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178" name="矩形 177"/>
            <p:cNvSpPr/>
            <p:nvPr/>
          </p:nvSpPr>
          <p:spPr>
            <a:xfrm rot="18908584">
              <a:off x="1009141" y="5099186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179" name="矩形 178"/>
            <p:cNvSpPr/>
            <p:nvPr/>
          </p:nvSpPr>
          <p:spPr>
            <a:xfrm rot="18908584">
              <a:off x="1207378" y="4978190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0" name="矩形 179"/>
            <p:cNvSpPr/>
            <p:nvPr/>
          </p:nvSpPr>
          <p:spPr>
            <a:xfrm rot="18908584">
              <a:off x="1578465" y="517607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81" name="矩形 180"/>
            <p:cNvSpPr/>
            <p:nvPr/>
          </p:nvSpPr>
          <p:spPr>
            <a:xfrm rot="18908584">
              <a:off x="2106185" y="517607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182" name="矩形 181"/>
            <p:cNvSpPr/>
            <p:nvPr/>
          </p:nvSpPr>
          <p:spPr>
            <a:xfrm rot="18908584">
              <a:off x="1846095" y="517607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183" name="矩形 182"/>
            <p:cNvSpPr/>
            <p:nvPr/>
          </p:nvSpPr>
          <p:spPr>
            <a:xfrm rot="18908584">
              <a:off x="2394217" y="5176071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1491983" y="6677583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Barley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780030" y="7131552"/>
            <a:ext cx="2164338" cy="1968021"/>
            <a:chOff x="780030" y="7131552"/>
            <a:chExt cx="2164338" cy="1968021"/>
          </a:xfrm>
        </p:grpSpPr>
        <p:pic>
          <p:nvPicPr>
            <p:cNvPr id="64" name="Picture 28" descr="C:\Users\12466\Desktop\新建文件夹 (2)\点接\Z9.jpg"/>
            <p:cNvPicPr>
              <a:picLocks noChangeAspect="1" noChangeArrowheads="1"/>
            </p:cNvPicPr>
            <p:nvPr/>
          </p:nvPicPr>
          <p:blipFill>
            <a:blip r:embed="rId48" cstate="print"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5564" y="7636887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2" name="Picture 36" descr="C:\Users\12466\Desktop\新建文件夹 (2)\点接\H.jpg"/>
            <p:cNvPicPr>
              <a:picLocks noChangeAspect="1" noChangeArrowheads="1"/>
            </p:cNvPicPr>
            <p:nvPr/>
          </p:nvPicPr>
          <p:blipFill>
            <a:blip r:embed="rId50" cstate="print">
              <a:extLst>
                <a:ext uri="{BEBA8EAE-BF5A-486C-A8C5-ECC9F3942E4B}">
                  <a14:imgProps xmlns:a14="http://schemas.microsoft.com/office/drawing/2010/main">
                    <a14:imgLayer r:embed="rId5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98696" y="7622371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3" name="Picture 37" descr="C:\Users\12466\Desktop\新建文件夹 (2)\点接\I.jpg"/>
            <p:cNvPicPr>
              <a:picLocks noChangeAspect="1" noChangeArrowheads="1"/>
            </p:cNvPicPr>
            <p:nvPr/>
          </p:nvPicPr>
          <p:blipFill>
            <a:blip r:embed="rId52" cstate="print">
              <a:extLst>
                <a:ext uri="{BEBA8EAE-BF5A-486C-A8C5-ECC9F3942E4B}">
                  <a14:imgProps xmlns:a14="http://schemas.microsoft.com/office/drawing/2010/main">
                    <a14:imgLayer r:embed="rId5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8633" y="7622370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6" name="Picture 12" descr="C:\Users\12466\Desktop\新建文件夹 (2)\点接\附图\131.jpg"/>
            <p:cNvPicPr>
              <a:picLocks noChangeAspect="1" noChangeArrowheads="1"/>
            </p:cNvPicPr>
            <p:nvPr/>
          </p:nvPicPr>
          <p:blipFill>
            <a:blip r:embed="rId54" cstate="print">
              <a:extLst>
                <a:ext uri="{BEBA8EAE-BF5A-486C-A8C5-ECC9F3942E4B}">
                  <a14:imgProps xmlns:a14="http://schemas.microsoft.com/office/drawing/2010/main">
                    <a14:imgLayer r:embed="rId5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1488" y="7636886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7" name="Picture 13" descr="C:\Users\12466\Desktop\新建文件夹 (2)\点接\附图\6b.jpg"/>
            <p:cNvPicPr>
              <a:picLocks noChangeAspect="1" noChangeArrowheads="1"/>
            </p:cNvPicPr>
            <p:nvPr/>
          </p:nvPicPr>
          <p:blipFill>
            <a:blip r:embed="rId56" cstate="print">
              <a:extLst>
                <a:ext uri="{BEBA8EAE-BF5A-486C-A8C5-ECC9F3942E4B}">
                  <a14:imgProps xmlns:a14="http://schemas.microsoft.com/office/drawing/2010/main">
                    <a14:imgLayer r:embed="rId5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6750" y="7636887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8" name="Picture 14" descr="C:\Users\12466\Desktop\新建文件夹 (2)\点接\附图\Z9.jpg"/>
            <p:cNvPicPr>
              <a:picLocks noChangeAspect="1" noChangeArrowheads="1"/>
            </p:cNvPicPr>
            <p:nvPr/>
          </p:nvPicPr>
          <p:blipFill>
            <a:blip r:embed="rId58" cstate="print">
              <a:extLst>
                <a:ext uri="{BEBA8EAE-BF5A-486C-A8C5-ECC9F3942E4B}">
                  <a14:imgProps xmlns:a14="http://schemas.microsoft.com/office/drawing/2010/main">
                    <a14:imgLayer r:embed="rId5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03167" y="7636887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C:\Users\12466\Desktop\补实验\疫情期间\点突变大麦\点接\附图\F新.jpg"/>
            <p:cNvPicPr>
              <a:picLocks noChangeAspect="1" noChangeArrowheads="1"/>
            </p:cNvPicPr>
            <p:nvPr/>
          </p:nvPicPr>
          <p:blipFill>
            <a:blip r:embed="rId60" cstate="print">
              <a:extLst>
                <a:ext uri="{BEBA8EAE-BF5A-486C-A8C5-ECC9F3942E4B}">
                  <a14:imgProps xmlns:a14="http://schemas.microsoft.com/office/drawing/2010/main">
                    <a14:imgLayer r:embed="rId6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48145" y="7637922"/>
              <a:ext cx="180000" cy="12500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4" name="矩形 183"/>
            <p:cNvSpPr/>
            <p:nvPr/>
          </p:nvSpPr>
          <p:spPr>
            <a:xfrm rot="18908584">
              <a:off x="780030" y="7373513"/>
              <a:ext cx="45397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131</a:t>
              </a:r>
            </a:p>
          </p:txBody>
        </p:sp>
        <p:sp>
          <p:nvSpPr>
            <p:cNvPr id="185" name="矩形 184"/>
            <p:cNvSpPr/>
            <p:nvPr/>
          </p:nvSpPr>
          <p:spPr>
            <a:xfrm rot="18908584">
              <a:off x="1009141" y="7262708"/>
              <a:ext cx="76815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mcase-1</a:t>
              </a:r>
            </a:p>
          </p:txBody>
        </p:sp>
        <p:sp>
          <p:nvSpPr>
            <p:cNvPr id="186" name="矩形 185"/>
            <p:cNvSpPr/>
            <p:nvPr/>
          </p:nvSpPr>
          <p:spPr>
            <a:xfrm rot="18908584">
              <a:off x="1236167" y="7131552"/>
              <a:ext cx="114005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Δamcase</a:t>
              </a:r>
              <a:r>
                <a:rPr lang="en-US" altLang="zh-CN" sz="900" i="1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/</a:t>
              </a:r>
              <a:r>
                <a:rPr lang="en-US" altLang="zh-CN" sz="900" i="1" dirty="0" err="1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AMCase</a:t>
              </a:r>
              <a:endParaRPr lang="zh-CN" altLang="en-US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7" name="矩形 186"/>
            <p:cNvSpPr/>
            <p:nvPr/>
          </p:nvSpPr>
          <p:spPr>
            <a:xfrm rot="18908584">
              <a:off x="1561531" y="7339593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33G</a:t>
              </a:r>
            </a:p>
          </p:txBody>
        </p:sp>
        <p:sp>
          <p:nvSpPr>
            <p:cNvPr id="188" name="矩形 187"/>
            <p:cNvSpPr/>
            <p:nvPr/>
          </p:nvSpPr>
          <p:spPr>
            <a:xfrm rot="18908584">
              <a:off x="2114652" y="7339593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15G</a:t>
              </a:r>
            </a:p>
          </p:txBody>
        </p:sp>
        <p:sp>
          <p:nvSpPr>
            <p:cNvPr id="189" name="矩形 188"/>
            <p:cNvSpPr/>
            <p:nvPr/>
          </p:nvSpPr>
          <p:spPr>
            <a:xfrm rot="18908584">
              <a:off x="1829161" y="7339593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173G</a:t>
              </a:r>
            </a:p>
          </p:txBody>
        </p:sp>
        <p:sp>
          <p:nvSpPr>
            <p:cNvPr id="190" name="矩形 189"/>
            <p:cNvSpPr/>
            <p:nvPr/>
          </p:nvSpPr>
          <p:spPr>
            <a:xfrm rot="18908584">
              <a:off x="2394217" y="7339593"/>
              <a:ext cx="55015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381G</a:t>
              </a: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1460910" y="8853352"/>
              <a:ext cx="584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Barley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24228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5</Words>
  <Application>Microsoft Office PowerPoint</Application>
  <PresentationFormat>A4 纸张(210x297 毫米)</PresentationFormat>
  <Paragraphs>1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宁</dc:creator>
  <cp:lastModifiedBy>焦玉霞</cp:lastModifiedBy>
  <cp:revision>5</cp:revision>
  <dcterms:created xsi:type="dcterms:W3CDTF">2021-07-07T14:30:05Z</dcterms:created>
  <dcterms:modified xsi:type="dcterms:W3CDTF">2021-07-08T11:39:25Z</dcterms:modified>
</cp:coreProperties>
</file>